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4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2730" y="72"/>
      </p:cViewPr>
      <p:guideLst>
        <p:guide orient="horz" pos="2551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nb-NO" smtClean="0"/>
              <a:t>Klikk for å redigere undertittelstil i mal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68992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43688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21648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43289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98368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30335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58969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66356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56503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43250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nb-NO" smtClean="0"/>
              <a:t>Klikk ikonet for å legge til et bil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5656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369A1-FC36-42BD-81C3-71BF5703EEBF}" type="datetimeFigureOut">
              <a:rPr lang="nb-NO" smtClean="0"/>
              <a:t>11.04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57878-EACD-404A-90B2-B045BD8DE09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07899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840" y="2760824"/>
            <a:ext cx="5448685" cy="1566024"/>
          </a:xfrm>
          <a:prstGeom prst="rect">
            <a:avLst/>
          </a:prstGeom>
        </p:spPr>
      </p:pic>
      <p:pic>
        <p:nvPicPr>
          <p:cNvPr id="6" name="Bilde 5"/>
          <p:cNvPicPr>
            <a:picLocks noChangeAspect="1"/>
          </p:cNvPicPr>
          <p:nvPr/>
        </p:nvPicPr>
        <p:blipFill rotWithShape="1">
          <a:blip r:embed="rId3"/>
          <a:srcRect t="1135"/>
          <a:stretch/>
        </p:blipFill>
        <p:spPr>
          <a:xfrm>
            <a:off x="1183864" y="630018"/>
            <a:ext cx="2205386" cy="21308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kstSylinder 6"/>
          <p:cNvSpPr txBox="1"/>
          <p:nvPr/>
        </p:nvSpPr>
        <p:spPr>
          <a:xfrm>
            <a:off x="3389250" y="979922"/>
            <a:ext cx="729687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/>
              <a:t>Wild-type</a:t>
            </a:r>
          </a:p>
        </p:txBody>
      </p:sp>
      <p:sp>
        <p:nvSpPr>
          <p:cNvPr id="8" name="TekstSylinder 7"/>
          <p:cNvSpPr txBox="1"/>
          <p:nvPr/>
        </p:nvSpPr>
        <p:spPr>
          <a:xfrm>
            <a:off x="3389250" y="2096647"/>
            <a:ext cx="2401619" cy="2559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63" dirty="0"/>
              <a:t>c.1037+522_1037+523delinsAA in </a:t>
            </a:r>
            <a:r>
              <a:rPr lang="nb-NO" sz="1063" i="1" dirty="0"/>
              <a:t>BBS7</a:t>
            </a:r>
            <a:r>
              <a:rPr lang="nb-NO" sz="1063" dirty="0"/>
              <a:t> </a:t>
            </a:r>
          </a:p>
        </p:txBody>
      </p:sp>
      <p:sp>
        <p:nvSpPr>
          <p:cNvPr id="9" name="Rektangel 8"/>
          <p:cNvSpPr/>
          <p:nvPr/>
        </p:nvSpPr>
        <p:spPr>
          <a:xfrm>
            <a:off x="364839" y="4472809"/>
            <a:ext cx="5083421" cy="1073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63" dirty="0" smtClean="0"/>
              <a:t>Additional file 1</a:t>
            </a:r>
            <a:r>
              <a:rPr lang="en-GB" sz="1063" dirty="0" smtClean="0"/>
              <a:t>: </a:t>
            </a:r>
            <a:r>
              <a:rPr lang="en-GB" sz="1063" dirty="0"/>
              <a:t>a) In </a:t>
            </a:r>
            <a:r>
              <a:rPr lang="en-GB" sz="1063" dirty="0" err="1"/>
              <a:t>silico</a:t>
            </a:r>
            <a:r>
              <a:rPr lang="en-GB" sz="1063" dirty="0"/>
              <a:t> prediction of the effect of the c.1037+522_1037+523delinsAA on a cryptic splice site in intron 10 in </a:t>
            </a:r>
            <a:r>
              <a:rPr lang="en-GB" sz="1063" i="1" dirty="0"/>
              <a:t>BBS7</a:t>
            </a:r>
            <a:r>
              <a:rPr lang="en-GB" sz="1063" dirty="0"/>
              <a:t> generated by </a:t>
            </a:r>
            <a:r>
              <a:rPr lang="en-GB" sz="1063" dirty="0" err="1"/>
              <a:t>AlaMut</a:t>
            </a:r>
            <a:r>
              <a:rPr lang="en-GB" sz="1063" dirty="0"/>
              <a:t> </a:t>
            </a:r>
            <a:r>
              <a:rPr lang="nb-NO" sz="1063" dirty="0"/>
              <a:t>Visual Software </a:t>
            </a:r>
            <a:r>
              <a:rPr lang="nb-NO" sz="1063" dirty="0" err="1"/>
              <a:t>version</a:t>
            </a:r>
            <a:r>
              <a:rPr lang="nb-NO" sz="1063" dirty="0"/>
              <a:t> 1.6.1 (</a:t>
            </a:r>
            <a:r>
              <a:rPr lang="nb-NO" sz="1063" dirty="0" err="1"/>
              <a:t>SOPHiA</a:t>
            </a:r>
            <a:r>
              <a:rPr lang="nb-NO" sz="1063" dirty="0"/>
              <a:t> GENETICS)</a:t>
            </a:r>
            <a:r>
              <a:rPr lang="en-GB" sz="1063" dirty="0"/>
              <a:t> including </a:t>
            </a:r>
            <a:r>
              <a:rPr lang="en-US" sz="1063" dirty="0" err="1"/>
              <a:t>SpliceSiteFinder</a:t>
            </a:r>
            <a:r>
              <a:rPr lang="en-US" sz="1063" dirty="0"/>
              <a:t>-like, </a:t>
            </a:r>
            <a:r>
              <a:rPr lang="en-US" sz="1063" dirty="0" err="1"/>
              <a:t>MaxEntScan</a:t>
            </a:r>
            <a:r>
              <a:rPr lang="en-US" sz="1063" dirty="0"/>
              <a:t>, NNSPLICE, </a:t>
            </a:r>
            <a:r>
              <a:rPr lang="en-US" sz="1063" dirty="0" err="1"/>
              <a:t>GeneSplicer</a:t>
            </a:r>
            <a:r>
              <a:rPr lang="en-US" sz="1063" dirty="0"/>
              <a:t>, and Human Splicing Finder</a:t>
            </a:r>
            <a:r>
              <a:rPr lang="en-GB" sz="1063" dirty="0"/>
              <a:t>.</a:t>
            </a:r>
          </a:p>
          <a:p>
            <a:r>
              <a:rPr lang="en-GB" sz="1063" dirty="0"/>
              <a:t>b) A cryptic acceptor splice site in position c.1037+310 and the strengthened donor splice site in position c.1037+519 create a possible </a:t>
            </a:r>
            <a:r>
              <a:rPr lang="en-GB" sz="1063" dirty="0" err="1"/>
              <a:t>pseudoexon</a:t>
            </a:r>
            <a:r>
              <a:rPr lang="en-GB" sz="1063" dirty="0"/>
              <a:t> of 209 nucleotides. </a:t>
            </a:r>
          </a:p>
        </p:txBody>
      </p:sp>
      <p:sp>
        <p:nvSpPr>
          <p:cNvPr id="10" name="TekstSylinder 9"/>
          <p:cNvSpPr txBox="1"/>
          <p:nvPr/>
        </p:nvSpPr>
        <p:spPr>
          <a:xfrm>
            <a:off x="216427" y="492024"/>
            <a:ext cx="325730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a)</a:t>
            </a:r>
          </a:p>
        </p:txBody>
      </p:sp>
      <p:sp>
        <p:nvSpPr>
          <p:cNvPr id="11" name="TekstSylinder 10"/>
          <p:cNvSpPr txBox="1"/>
          <p:nvPr/>
        </p:nvSpPr>
        <p:spPr>
          <a:xfrm>
            <a:off x="216427" y="2652746"/>
            <a:ext cx="335348" cy="310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16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836736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5</Words>
  <Application>Microsoft Office PowerPoint</Application>
  <PresentationFormat>Egendefinert</PresentationFormat>
  <Paragraphs>6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Cecilie Fremstad Rustad</dc:creator>
  <cp:lastModifiedBy>Cecilie Fremstad Rustad</cp:lastModifiedBy>
  <cp:revision>3</cp:revision>
  <dcterms:created xsi:type="dcterms:W3CDTF">2024-04-10T12:51:51Z</dcterms:created>
  <dcterms:modified xsi:type="dcterms:W3CDTF">2024-04-11T07:04:33Z</dcterms:modified>
</cp:coreProperties>
</file>